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>
        <p:scale>
          <a:sx n="90" d="100"/>
          <a:sy n="90" d="100"/>
        </p:scale>
        <p:origin x="-1452" y="57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Manuscript\Figure%20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RNASeq\Manuscript\Figure%20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Foglio1!$D$3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Foglio1!$C$4:$C$16</c:f>
              <c:strCache>
                <c:ptCount val="13"/>
                <c:pt idx="0">
                  <c:v>Unknown function</c:v>
                </c:pt>
                <c:pt idx="1">
                  <c:v>Metabolic process</c:v>
                </c:pt>
                <c:pt idx="2">
                  <c:v>Signal transduction </c:v>
                </c:pt>
                <c:pt idx="3">
                  <c:v>Transport </c:v>
                </c:pt>
                <c:pt idx="4">
                  <c:v>Resistance </c:v>
                </c:pt>
                <c:pt idx="5">
                  <c:v>Miscellanea</c:v>
                </c:pt>
                <c:pt idx="6">
                  <c:v>Response to stress </c:v>
                </c:pt>
                <c:pt idx="7">
                  <c:v>Secondary metabolism</c:v>
                </c:pt>
                <c:pt idx="8">
                  <c:v>Cell component</c:v>
                </c:pt>
                <c:pt idx="9">
                  <c:v>Cell wall</c:v>
                </c:pt>
                <c:pt idx="10">
                  <c:v>Electron/Energy </c:v>
                </c:pt>
                <c:pt idx="11">
                  <c:v>Proteolysis</c:v>
                </c:pt>
                <c:pt idx="12">
                  <c:v>Photosynthesis </c:v>
                </c:pt>
              </c:strCache>
            </c:strRef>
          </c:cat>
          <c:val>
            <c:numRef>
              <c:f>Foglio1!$D$4:$D$16</c:f>
              <c:numCache>
                <c:formatCode>General</c:formatCode>
                <c:ptCount val="13"/>
                <c:pt idx="0">
                  <c:v>409</c:v>
                </c:pt>
                <c:pt idx="1">
                  <c:v>415</c:v>
                </c:pt>
                <c:pt idx="2">
                  <c:v>263</c:v>
                </c:pt>
                <c:pt idx="3">
                  <c:v>122</c:v>
                </c:pt>
                <c:pt idx="4">
                  <c:v>115</c:v>
                </c:pt>
                <c:pt idx="5">
                  <c:v>82</c:v>
                </c:pt>
                <c:pt idx="6">
                  <c:v>67</c:v>
                </c:pt>
                <c:pt idx="7">
                  <c:v>56</c:v>
                </c:pt>
                <c:pt idx="8">
                  <c:v>30</c:v>
                </c:pt>
                <c:pt idx="9">
                  <c:v>46</c:v>
                </c:pt>
                <c:pt idx="10">
                  <c:v>30</c:v>
                </c:pt>
                <c:pt idx="11">
                  <c:v>17</c:v>
                </c:pt>
                <c:pt idx="12">
                  <c:v>4</c:v>
                </c:pt>
              </c:numCache>
            </c:numRef>
          </c:val>
        </c:ser>
        <c:ser>
          <c:idx val="1"/>
          <c:order val="1"/>
          <c:tx>
            <c:strRef>
              <c:f>Foglio1!$E$3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Foglio1!$C$4:$C$16</c:f>
              <c:strCache>
                <c:ptCount val="13"/>
                <c:pt idx="0">
                  <c:v>Unknown function</c:v>
                </c:pt>
                <c:pt idx="1">
                  <c:v>Metabolic process</c:v>
                </c:pt>
                <c:pt idx="2">
                  <c:v>Signal transduction </c:v>
                </c:pt>
                <c:pt idx="3">
                  <c:v>Transport </c:v>
                </c:pt>
                <c:pt idx="4">
                  <c:v>Resistance </c:v>
                </c:pt>
                <c:pt idx="5">
                  <c:v>Miscellanea</c:v>
                </c:pt>
                <c:pt idx="6">
                  <c:v>Response to stress </c:v>
                </c:pt>
                <c:pt idx="7">
                  <c:v>Secondary metabolism</c:v>
                </c:pt>
                <c:pt idx="8">
                  <c:v>Cell component</c:v>
                </c:pt>
                <c:pt idx="9">
                  <c:v>Cell wall</c:v>
                </c:pt>
                <c:pt idx="10">
                  <c:v>Electron/Energy </c:v>
                </c:pt>
                <c:pt idx="11">
                  <c:v>Proteolysis</c:v>
                </c:pt>
                <c:pt idx="12">
                  <c:v>Photosynthesis </c:v>
                </c:pt>
              </c:strCache>
            </c:strRef>
          </c:cat>
          <c:val>
            <c:numRef>
              <c:f>Foglio1!$E$4:$E$16</c:f>
              <c:numCache>
                <c:formatCode>General</c:formatCode>
                <c:ptCount val="13"/>
                <c:pt idx="0">
                  <c:v>226</c:v>
                </c:pt>
                <c:pt idx="1">
                  <c:v>142</c:v>
                </c:pt>
                <c:pt idx="2">
                  <c:v>52</c:v>
                </c:pt>
                <c:pt idx="3">
                  <c:v>31</c:v>
                </c:pt>
                <c:pt idx="4">
                  <c:v>19</c:v>
                </c:pt>
                <c:pt idx="5">
                  <c:v>31</c:v>
                </c:pt>
                <c:pt idx="6">
                  <c:v>25</c:v>
                </c:pt>
                <c:pt idx="7">
                  <c:v>10</c:v>
                </c:pt>
                <c:pt idx="8">
                  <c:v>25</c:v>
                </c:pt>
                <c:pt idx="9">
                  <c:v>6</c:v>
                </c:pt>
                <c:pt idx="10">
                  <c:v>18</c:v>
                </c:pt>
                <c:pt idx="11">
                  <c:v>7</c:v>
                </c:pt>
                <c:pt idx="12">
                  <c:v>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8263808"/>
        <c:axId val="65078400"/>
      </c:barChart>
      <c:catAx>
        <c:axId val="58263808"/>
        <c:scaling>
          <c:orientation val="minMax"/>
        </c:scaling>
        <c:delete val="0"/>
        <c:axPos val="l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65078400"/>
        <c:crosses val="autoZero"/>
        <c:auto val="1"/>
        <c:lblAlgn val="ctr"/>
        <c:lblOffset val="100"/>
        <c:noMultiLvlLbl val="0"/>
      </c:catAx>
      <c:valAx>
        <c:axId val="65078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582638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Foglio1!$J$3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Foglio1!$I$4:$I$16</c:f>
              <c:strCache>
                <c:ptCount val="13"/>
                <c:pt idx="0">
                  <c:v>Unknown function</c:v>
                </c:pt>
                <c:pt idx="1">
                  <c:v>Metabolic process </c:v>
                </c:pt>
                <c:pt idx="2">
                  <c:v>Signal transduction</c:v>
                </c:pt>
                <c:pt idx="3">
                  <c:v>Resistance</c:v>
                </c:pt>
                <c:pt idx="4">
                  <c:v>Transport</c:v>
                </c:pt>
                <c:pt idx="5">
                  <c:v>Miscellanea</c:v>
                </c:pt>
                <c:pt idx="6">
                  <c:v>Response to stress </c:v>
                </c:pt>
                <c:pt idx="7">
                  <c:v>Secondary metabolism</c:v>
                </c:pt>
                <c:pt idx="8">
                  <c:v>Cell wall</c:v>
                </c:pt>
                <c:pt idx="9">
                  <c:v>Electron/Energy </c:v>
                </c:pt>
                <c:pt idx="10">
                  <c:v>Cell component</c:v>
                </c:pt>
                <c:pt idx="11">
                  <c:v>Proteolysis</c:v>
                </c:pt>
                <c:pt idx="12">
                  <c:v>Photosynthesis</c:v>
                </c:pt>
              </c:strCache>
            </c:strRef>
          </c:cat>
          <c:val>
            <c:numRef>
              <c:f>Foglio1!$J$4:$J$16</c:f>
              <c:numCache>
                <c:formatCode>General</c:formatCode>
                <c:ptCount val="13"/>
                <c:pt idx="0">
                  <c:v>654</c:v>
                </c:pt>
                <c:pt idx="1">
                  <c:v>433</c:v>
                </c:pt>
                <c:pt idx="2">
                  <c:v>335</c:v>
                </c:pt>
                <c:pt idx="3">
                  <c:v>130</c:v>
                </c:pt>
                <c:pt idx="4">
                  <c:v>123</c:v>
                </c:pt>
                <c:pt idx="5">
                  <c:v>79</c:v>
                </c:pt>
                <c:pt idx="6">
                  <c:v>76</c:v>
                </c:pt>
                <c:pt idx="7">
                  <c:v>63</c:v>
                </c:pt>
                <c:pt idx="8">
                  <c:v>56</c:v>
                </c:pt>
                <c:pt idx="9">
                  <c:v>23</c:v>
                </c:pt>
                <c:pt idx="10">
                  <c:v>23</c:v>
                </c:pt>
                <c:pt idx="11">
                  <c:v>25</c:v>
                </c:pt>
                <c:pt idx="12">
                  <c:v>4</c:v>
                </c:pt>
              </c:numCache>
            </c:numRef>
          </c:val>
        </c:ser>
        <c:ser>
          <c:idx val="1"/>
          <c:order val="1"/>
          <c:tx>
            <c:strRef>
              <c:f>Foglio1!$K$3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Foglio1!$I$4:$I$16</c:f>
              <c:strCache>
                <c:ptCount val="13"/>
                <c:pt idx="0">
                  <c:v>Unknown function</c:v>
                </c:pt>
                <c:pt idx="1">
                  <c:v>Metabolic process </c:v>
                </c:pt>
                <c:pt idx="2">
                  <c:v>Signal transduction</c:v>
                </c:pt>
                <c:pt idx="3">
                  <c:v>Resistance</c:v>
                </c:pt>
                <c:pt idx="4">
                  <c:v>Transport</c:v>
                </c:pt>
                <c:pt idx="5">
                  <c:v>Miscellanea</c:v>
                </c:pt>
                <c:pt idx="6">
                  <c:v>Response to stress </c:v>
                </c:pt>
                <c:pt idx="7">
                  <c:v>Secondary metabolism</c:v>
                </c:pt>
                <c:pt idx="8">
                  <c:v>Cell wall</c:v>
                </c:pt>
                <c:pt idx="9">
                  <c:v>Electron/Energy </c:v>
                </c:pt>
                <c:pt idx="10">
                  <c:v>Cell component</c:v>
                </c:pt>
                <c:pt idx="11">
                  <c:v>Proteolysis</c:v>
                </c:pt>
                <c:pt idx="12">
                  <c:v>Photosynthesis</c:v>
                </c:pt>
              </c:strCache>
            </c:strRef>
          </c:cat>
          <c:val>
            <c:numRef>
              <c:f>Foglio1!$K$4:$K$16</c:f>
              <c:numCache>
                <c:formatCode>General</c:formatCode>
                <c:ptCount val="13"/>
                <c:pt idx="0">
                  <c:v>178</c:v>
                </c:pt>
                <c:pt idx="1">
                  <c:v>86</c:v>
                </c:pt>
                <c:pt idx="2">
                  <c:v>44</c:v>
                </c:pt>
                <c:pt idx="3">
                  <c:v>20</c:v>
                </c:pt>
                <c:pt idx="4">
                  <c:v>18</c:v>
                </c:pt>
                <c:pt idx="5">
                  <c:v>28</c:v>
                </c:pt>
                <c:pt idx="6">
                  <c:v>11</c:v>
                </c:pt>
                <c:pt idx="7">
                  <c:v>4</c:v>
                </c:pt>
                <c:pt idx="8">
                  <c:v>6</c:v>
                </c:pt>
                <c:pt idx="9">
                  <c:v>7</c:v>
                </c:pt>
                <c:pt idx="10">
                  <c:v>6</c:v>
                </c:pt>
                <c:pt idx="11">
                  <c:v>3</c:v>
                </c:pt>
                <c:pt idx="12">
                  <c:v>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7228800"/>
        <c:axId val="87230336"/>
      </c:barChart>
      <c:catAx>
        <c:axId val="87228800"/>
        <c:scaling>
          <c:orientation val="minMax"/>
        </c:scaling>
        <c:delete val="0"/>
        <c:axPos val="l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87230336"/>
        <c:crosses val="autoZero"/>
        <c:auto val="1"/>
        <c:lblAlgn val="ctr"/>
        <c:lblOffset val="100"/>
        <c:noMultiLvlLbl val="0"/>
      </c:catAx>
      <c:valAx>
        <c:axId val="872303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8722880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6CC6-D46E-4319-960E-D6C6483A0870}" type="datetimeFigureOut">
              <a:rPr lang="it-IT" smtClean="0"/>
              <a:t>05/0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88DD-263C-42D0-AC61-D6469B39B83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7794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6CC6-D46E-4319-960E-D6C6483A0870}" type="datetimeFigureOut">
              <a:rPr lang="it-IT" smtClean="0"/>
              <a:t>05/0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88DD-263C-42D0-AC61-D6469B39B83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9292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6CC6-D46E-4319-960E-D6C6483A0870}" type="datetimeFigureOut">
              <a:rPr lang="it-IT" smtClean="0"/>
              <a:t>05/0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88DD-263C-42D0-AC61-D6469B39B83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5218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6CC6-D46E-4319-960E-D6C6483A0870}" type="datetimeFigureOut">
              <a:rPr lang="it-IT" smtClean="0"/>
              <a:t>05/0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88DD-263C-42D0-AC61-D6469B39B83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1515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6CC6-D46E-4319-960E-D6C6483A0870}" type="datetimeFigureOut">
              <a:rPr lang="it-IT" smtClean="0"/>
              <a:t>05/0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88DD-263C-42D0-AC61-D6469B39B83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9006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6CC6-D46E-4319-960E-D6C6483A0870}" type="datetimeFigureOut">
              <a:rPr lang="it-IT" smtClean="0"/>
              <a:t>05/0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88DD-263C-42D0-AC61-D6469B39B83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2894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6CC6-D46E-4319-960E-D6C6483A0870}" type="datetimeFigureOut">
              <a:rPr lang="it-IT" smtClean="0"/>
              <a:t>05/02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88DD-263C-42D0-AC61-D6469B39B83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2432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6CC6-D46E-4319-960E-D6C6483A0870}" type="datetimeFigureOut">
              <a:rPr lang="it-IT" smtClean="0"/>
              <a:t>05/02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88DD-263C-42D0-AC61-D6469B39B83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1964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6CC6-D46E-4319-960E-D6C6483A0870}" type="datetimeFigureOut">
              <a:rPr lang="it-IT" smtClean="0"/>
              <a:t>05/02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88DD-263C-42D0-AC61-D6469B39B83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9509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6CC6-D46E-4319-960E-D6C6483A0870}" type="datetimeFigureOut">
              <a:rPr lang="it-IT" smtClean="0"/>
              <a:t>05/0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88DD-263C-42D0-AC61-D6469B39B83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6259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6CC6-D46E-4319-960E-D6C6483A0870}" type="datetimeFigureOut">
              <a:rPr lang="it-IT" smtClean="0"/>
              <a:t>05/02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888DD-263C-42D0-AC61-D6469B39B83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0070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8D6CC6-D46E-4319-960E-D6C6483A0870}" type="datetimeFigureOut">
              <a:rPr lang="it-IT" smtClean="0"/>
              <a:t>05/0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0888DD-263C-42D0-AC61-D6469B39B83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86849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uppo 15"/>
          <p:cNvGrpSpPr/>
          <p:nvPr/>
        </p:nvGrpSpPr>
        <p:grpSpPr>
          <a:xfrm>
            <a:off x="7380312" y="3383414"/>
            <a:ext cx="774836" cy="451212"/>
            <a:chOff x="7380312" y="3383414"/>
            <a:chExt cx="774836" cy="451212"/>
          </a:xfrm>
        </p:grpSpPr>
        <p:sp>
          <p:nvSpPr>
            <p:cNvPr id="9" name="Rettangolo 8"/>
            <p:cNvSpPr/>
            <p:nvPr/>
          </p:nvSpPr>
          <p:spPr>
            <a:xfrm>
              <a:off x="7380312" y="3501008"/>
              <a:ext cx="72008" cy="72008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" name="Rettangolo 9"/>
            <p:cNvSpPr/>
            <p:nvPr/>
          </p:nvSpPr>
          <p:spPr>
            <a:xfrm>
              <a:off x="7385938" y="3679286"/>
              <a:ext cx="72008" cy="7200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7432068" y="3573016"/>
              <a:ext cx="72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essed</a:t>
              </a:r>
              <a:endParaRPr lang="it-IT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7435068" y="3383414"/>
              <a:ext cx="72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it-IT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uced</a:t>
              </a:r>
              <a:endParaRPr lang="it-IT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" name="Gruppo 14"/>
          <p:cNvGrpSpPr/>
          <p:nvPr/>
        </p:nvGrpSpPr>
        <p:grpSpPr>
          <a:xfrm>
            <a:off x="7380312" y="61876"/>
            <a:ext cx="771836" cy="448756"/>
            <a:chOff x="7380312" y="61876"/>
            <a:chExt cx="771836" cy="448756"/>
          </a:xfrm>
        </p:grpSpPr>
        <p:sp>
          <p:nvSpPr>
            <p:cNvPr id="2" name="Rettangolo 1"/>
            <p:cNvSpPr/>
            <p:nvPr/>
          </p:nvSpPr>
          <p:spPr>
            <a:xfrm>
              <a:off x="7380312" y="188640"/>
              <a:ext cx="72008" cy="72008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" name="Rettangolo 5"/>
            <p:cNvSpPr/>
            <p:nvPr/>
          </p:nvSpPr>
          <p:spPr>
            <a:xfrm>
              <a:off x="7385938" y="366918"/>
              <a:ext cx="72008" cy="7200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" name="CasellaDiTesto 2"/>
            <p:cNvSpPr txBox="1"/>
            <p:nvPr/>
          </p:nvSpPr>
          <p:spPr>
            <a:xfrm>
              <a:off x="7420816" y="61876"/>
              <a:ext cx="72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it-IT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uced</a:t>
              </a:r>
              <a:endParaRPr lang="it-IT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7432068" y="249022"/>
              <a:ext cx="72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essed</a:t>
              </a:r>
              <a:endParaRPr lang="it-IT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" name="CasellaDiTesto 16"/>
          <p:cNvSpPr txBox="1"/>
          <p:nvPr/>
        </p:nvSpPr>
        <p:spPr>
          <a:xfrm>
            <a:off x="5220072" y="-27384"/>
            <a:ext cx="864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441</a:t>
            </a:r>
            <a:endParaRPr lang="it-IT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>
            <a:off x="5220072" y="3481263"/>
            <a:ext cx="864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354</a:t>
            </a:r>
            <a:endParaRPr lang="it-IT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>
            <a:off x="6769744" y="2717546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.2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>
            <a:off x="4168830" y="781412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3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4160204" y="565388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1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CasellaDiTesto 21"/>
          <p:cNvSpPr txBox="1"/>
          <p:nvPr/>
        </p:nvSpPr>
        <p:spPr>
          <a:xfrm>
            <a:off x="4067944" y="349908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1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CasellaDiTesto 22"/>
          <p:cNvSpPr txBox="1"/>
          <p:nvPr/>
        </p:nvSpPr>
        <p:spPr>
          <a:xfrm>
            <a:off x="4355976" y="1430028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1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CasellaDiTesto 23"/>
          <p:cNvSpPr txBox="1"/>
          <p:nvPr/>
        </p:nvSpPr>
        <p:spPr>
          <a:xfrm>
            <a:off x="4194708" y="1213460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9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CasellaDiTesto 24"/>
          <p:cNvSpPr txBox="1"/>
          <p:nvPr/>
        </p:nvSpPr>
        <p:spPr>
          <a:xfrm>
            <a:off x="4174456" y="997436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4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5317958" y="2282794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4453862" y="1646052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CasellaDiTesto 27"/>
          <p:cNvSpPr txBox="1"/>
          <p:nvPr/>
        </p:nvSpPr>
        <p:spPr>
          <a:xfrm>
            <a:off x="4546122" y="1862620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CasellaDiTesto 28"/>
          <p:cNvSpPr txBox="1"/>
          <p:nvPr/>
        </p:nvSpPr>
        <p:spPr>
          <a:xfrm>
            <a:off x="4626756" y="2078644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8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CasellaDiTesto 29"/>
          <p:cNvSpPr txBox="1"/>
          <p:nvPr/>
        </p:nvSpPr>
        <p:spPr>
          <a:xfrm>
            <a:off x="6441582" y="2510692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.8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CasellaDiTesto 30"/>
          <p:cNvSpPr txBox="1"/>
          <p:nvPr/>
        </p:nvSpPr>
        <p:spPr>
          <a:xfrm>
            <a:off x="3995936" y="143054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3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CasellaDiTesto 32"/>
          <p:cNvSpPr txBox="1"/>
          <p:nvPr/>
        </p:nvSpPr>
        <p:spPr>
          <a:xfrm>
            <a:off x="6764139" y="6206971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4.1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CasellaDiTesto 33"/>
          <p:cNvSpPr txBox="1"/>
          <p:nvPr/>
        </p:nvSpPr>
        <p:spPr>
          <a:xfrm>
            <a:off x="4059318" y="4290096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2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CasellaDiTesto 34"/>
          <p:cNvSpPr txBox="1"/>
          <p:nvPr/>
        </p:nvSpPr>
        <p:spPr>
          <a:xfrm>
            <a:off x="4059318" y="4065446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2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CasellaDiTesto 35"/>
          <p:cNvSpPr txBox="1"/>
          <p:nvPr/>
        </p:nvSpPr>
        <p:spPr>
          <a:xfrm>
            <a:off x="4050692" y="3849966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1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CasellaDiTesto 36"/>
          <p:cNvSpPr txBox="1"/>
          <p:nvPr/>
        </p:nvSpPr>
        <p:spPr>
          <a:xfrm>
            <a:off x="4266716" y="4938712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6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CasellaDiTesto 37"/>
          <p:cNvSpPr txBox="1"/>
          <p:nvPr/>
        </p:nvSpPr>
        <p:spPr>
          <a:xfrm>
            <a:off x="4165830" y="4713518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7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CasellaDiTesto 38"/>
          <p:cNvSpPr txBox="1"/>
          <p:nvPr/>
        </p:nvSpPr>
        <p:spPr>
          <a:xfrm>
            <a:off x="4157204" y="4497494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5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CasellaDiTesto 39"/>
          <p:cNvSpPr txBox="1"/>
          <p:nvPr/>
        </p:nvSpPr>
        <p:spPr>
          <a:xfrm>
            <a:off x="5274828" y="5785012"/>
            <a:ext cx="8554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.5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CasellaDiTesto 40"/>
          <p:cNvSpPr txBox="1"/>
          <p:nvPr/>
        </p:nvSpPr>
        <p:spPr>
          <a:xfrm>
            <a:off x="4330098" y="5154736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4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CasellaDiTesto 41"/>
          <p:cNvSpPr txBox="1"/>
          <p:nvPr/>
        </p:nvSpPr>
        <p:spPr>
          <a:xfrm>
            <a:off x="4453862" y="5371304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8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CasellaDiTesto 42"/>
          <p:cNvSpPr txBox="1"/>
          <p:nvPr/>
        </p:nvSpPr>
        <p:spPr>
          <a:xfrm>
            <a:off x="4471114" y="5578702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1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CasellaDiTesto 43"/>
          <p:cNvSpPr txBox="1"/>
          <p:nvPr/>
        </p:nvSpPr>
        <p:spPr>
          <a:xfrm>
            <a:off x="5778884" y="5988940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.3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CasellaDiTesto 44"/>
          <p:cNvSpPr txBox="1"/>
          <p:nvPr/>
        </p:nvSpPr>
        <p:spPr>
          <a:xfrm>
            <a:off x="3995936" y="3633942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%</a:t>
            </a:r>
            <a:endParaRPr lang="it-IT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CasellaDiTesto 3"/>
          <p:cNvSpPr txBox="1"/>
          <p:nvPr/>
        </p:nvSpPr>
        <p:spPr>
          <a:xfrm>
            <a:off x="2494990" y="29659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CasellaDiTesto 47"/>
          <p:cNvSpPr txBox="1"/>
          <p:nvPr/>
        </p:nvSpPr>
        <p:spPr>
          <a:xfrm>
            <a:off x="2483768" y="3522494"/>
            <a:ext cx="288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49" name="Grafico 4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0259369"/>
              </p:ext>
            </p:extLst>
          </p:nvPr>
        </p:nvGraphicFramePr>
        <p:xfrm>
          <a:off x="2286016" y="49324"/>
          <a:ext cx="4860000" cy="32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0" name="Grafico 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3218977"/>
              </p:ext>
            </p:extLst>
          </p:nvPr>
        </p:nvGraphicFramePr>
        <p:xfrm>
          <a:off x="2286016" y="3534736"/>
          <a:ext cx="4860000" cy="32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39521068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5</TotalTime>
  <Words>60</Words>
  <Application>Microsoft Office PowerPoint</Application>
  <PresentationFormat>Presentazione su schermo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dmin</dc:creator>
  <cp:lastModifiedBy>Admin</cp:lastModifiedBy>
  <cp:revision>20</cp:revision>
  <dcterms:created xsi:type="dcterms:W3CDTF">2013-10-10T15:00:52Z</dcterms:created>
  <dcterms:modified xsi:type="dcterms:W3CDTF">2014-02-05T10:20:01Z</dcterms:modified>
</cp:coreProperties>
</file>